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883" autoAdjust="0"/>
  </p:normalViewPr>
  <p:slideViewPr>
    <p:cSldViewPr snapToGrid="0">
      <p:cViewPr varScale="1">
        <p:scale>
          <a:sx n="105" d="100"/>
          <a:sy n="105" d="100"/>
        </p:scale>
        <p:origin x="179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6698CB-A460-4AE5-9691-A8CA985360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2BEF8B7-708F-45D4-9F1B-602B68F198F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F97DB9-CA08-478D-9DAE-7C6540DCCD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320BF-079E-42C0-90FB-5233FB978171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95903C-8063-4025-8EF5-CFA20E6384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511C47-19CA-4728-BFF0-09DFAFFE4C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E45B2-28AC-4596-A384-72E867898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97340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BA311E-1BD5-48B9-99F5-6C560DCCCE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9371B4-34C8-488C-8695-E874CB34C3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0DB428-0298-41B6-9B81-D03E5C7C34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320BF-079E-42C0-90FB-5233FB978171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BD83D7-A995-446C-AD89-AC0EDE86B9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D4AF86-21A0-4190-BACB-7658533648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E45B2-28AC-4596-A384-72E867898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3761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088D786-83C0-47BD-B0E0-EE17962EF9E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B8F0B9-ED86-43EE-A640-5045EFD92D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8F545D-FB11-4E21-9AA4-EA27BC4241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320BF-079E-42C0-90FB-5233FB978171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73EFB7-1ED3-4024-952D-C608BCD6DA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2932F3-164E-4E8E-ADB2-1F0D2FA90D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E45B2-28AC-4596-A384-72E867898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6000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F3EA8E-5EDC-40F5-BC1A-AA9539A772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29A49A-1D60-4F16-B68F-A1C1152FFA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CD969F-91E5-4F20-A023-C46E1D330D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320BF-079E-42C0-90FB-5233FB978171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39CD5B-FF69-4766-B757-8068DC31BC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B66399-874F-4358-A97F-CE5E46B4B5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E45B2-28AC-4596-A384-72E867898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0537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297023-B56F-4678-B64B-86A368790D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759416-34CE-4A0E-AE6C-EEC46DB77F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AB70F2-AB97-4046-B4BE-8A2C0E9EA1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320BF-079E-42C0-90FB-5233FB978171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A5A0D3-0AD2-401D-A540-969EBC3088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2DD99F-BFB9-4EE5-8D1E-5B4467D1A6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E45B2-28AC-4596-A384-72E867898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21348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742681-9B9C-43DD-A579-D910CE58D4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666B32-CEA3-42CE-AF09-6B5B43F3EC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5DC12A-BB1E-45C4-9D7D-F7AD268F21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5BAB85-150A-4A21-9F76-6DD01F07BC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320BF-079E-42C0-90FB-5233FB978171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DEDB1E-4B42-4AF2-B32D-4796FC082E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19F3B6-8785-4FB8-B239-2AFC63D7E7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E45B2-28AC-4596-A384-72E867898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8283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414EC3-A388-480F-B428-FFF29F7652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F460FC-C955-4BC6-BCED-77AD95549D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121A06-2FA7-46F7-AC8E-BA6DF89C21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7DF7F68-1110-4434-9C5F-3AB00E4B78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A4F9467-0AFD-49E5-A400-97459FD2C1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62A35BE-8C81-40DF-A7DF-34D635B99C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320BF-079E-42C0-90FB-5233FB978171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DAA364D-1315-47D2-AC66-A13EC93E2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7F39C77-9CFD-40D8-8949-68D35513AD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E45B2-28AC-4596-A384-72E867898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8265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F210A4-CB15-4046-B553-CE8EDDFAF4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68354EE-DD47-442E-B9BE-3111880EDB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320BF-079E-42C0-90FB-5233FB978171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138FF1-5337-4D79-83AA-5112F230BE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50AA24C-1E86-47A6-9D91-4E08C40033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E45B2-28AC-4596-A384-72E867898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22836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5FB972B-92AC-42CA-8A44-E00E7E0DFF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320BF-079E-42C0-90FB-5233FB978171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7C10528-43BB-4378-AE46-7725C242DD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E5D3578-DFE7-450A-9D7F-0F9DB1C05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E45B2-28AC-4596-A384-72E867898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83390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B97AAF-4D3E-4A76-8D04-4A2104D4CC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1F25A0-5AD4-4342-9CCA-C732EC534C3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97D5DF8-727D-418D-8BFD-C688526126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3E14F4-C110-484E-BBCB-419F9F4A7E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320BF-079E-42C0-90FB-5233FB978171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9F92CF-91A5-4FC4-974D-1070A648DB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587C73-4025-4EAD-932E-4ACAE17C6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E45B2-28AC-4596-A384-72E867898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64205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02D5B7-A08E-4AD2-A935-F70264DF8A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541AC55-DCA7-4BD3-BCD7-8DDAC127018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19FFD5-0960-4DE1-82E7-EFFB4652C4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D7992E-8F43-4E14-A773-C43D52AFAF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320BF-079E-42C0-90FB-5233FB978171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3DC5A3B-D426-4D63-8E36-5FBAB68B05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341224-DDBF-4C5C-921E-1365BA4E22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E45B2-28AC-4596-A384-72E867898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08008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33AAD58-058B-420B-92C3-8A23B4B490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C15D38-0964-474D-B1DC-36AA9940CD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6E5092-BE90-4B0E-B3FF-7CDB5617614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A320BF-079E-42C0-90FB-5233FB978171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9FA5D1-DE25-4F3F-AE33-8E008EFB86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0448DA-BA12-4F21-BCE0-3CAF3921838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9E45B2-28AC-4596-A384-72E867898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34923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001F520-325F-4B3D-85EE-67041021C5B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</a:blip>
          <a:srcRect l="13144" t="8189" r="3637" b="12471"/>
          <a:stretch/>
        </p:blipFill>
        <p:spPr>
          <a:xfrm>
            <a:off x="481692" y="727498"/>
            <a:ext cx="1661532" cy="178909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11AE82C-F4F2-4FAB-98CC-BA8A9FC5D5AE}"/>
              </a:ext>
            </a:extLst>
          </p:cNvPr>
          <p:cNvSpPr txBox="1"/>
          <p:nvPr/>
        </p:nvSpPr>
        <p:spPr>
          <a:xfrm>
            <a:off x="478597" y="442875"/>
            <a:ext cx="224139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CHUK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D51DFAD-187C-4941-942A-6CF0CAB46813}"/>
              </a:ext>
            </a:extLst>
          </p:cNvPr>
          <p:cNvSpPr txBox="1"/>
          <p:nvPr/>
        </p:nvSpPr>
        <p:spPr>
          <a:xfrm>
            <a:off x="38733" y="1565680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8.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233E7BC-F26E-4B77-8B34-36488714C455}"/>
              </a:ext>
            </a:extLst>
          </p:cNvPr>
          <p:cNvSpPr txBox="1"/>
          <p:nvPr/>
        </p:nvSpPr>
        <p:spPr>
          <a:xfrm>
            <a:off x="38733" y="953316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8.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EB29889-F1AD-43ED-B1E1-13604186D3EF}"/>
              </a:ext>
            </a:extLst>
          </p:cNvPr>
          <p:cNvSpPr txBox="1"/>
          <p:nvPr/>
        </p:nvSpPr>
        <p:spPr>
          <a:xfrm>
            <a:off x="38733" y="2178043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7.9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AB21D129-CF86-4EE6-92CE-8080C6DDF72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grayscl/>
          </a:blip>
          <a:srcRect l="1012" b="970"/>
          <a:stretch/>
        </p:blipFill>
        <p:spPr>
          <a:xfrm>
            <a:off x="2762006" y="702495"/>
            <a:ext cx="1664208" cy="1792224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20D342C5-DD65-401C-B55D-97A9938D29FE}"/>
              </a:ext>
            </a:extLst>
          </p:cNvPr>
          <p:cNvSpPr txBox="1"/>
          <p:nvPr/>
        </p:nvSpPr>
        <p:spPr>
          <a:xfrm>
            <a:off x="5029843" y="442875"/>
            <a:ext cx="222082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IKBKG variant3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1BE9106-083C-4CF4-97E3-C04511F0F883}"/>
              </a:ext>
            </a:extLst>
          </p:cNvPr>
          <p:cNvSpPr txBox="1"/>
          <p:nvPr/>
        </p:nvSpPr>
        <p:spPr>
          <a:xfrm>
            <a:off x="2330626" y="917159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6.9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EEB81A6-6965-411F-BE77-2A97B41834B8}"/>
              </a:ext>
            </a:extLst>
          </p:cNvPr>
          <p:cNvSpPr txBox="1"/>
          <p:nvPr/>
        </p:nvSpPr>
        <p:spPr>
          <a:xfrm>
            <a:off x="2330626" y="1585281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6.8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F22EF589-CA70-49C8-827A-7F327DCC4CCC}"/>
              </a:ext>
            </a:extLst>
          </p:cNvPr>
          <p:cNvPicPr preferRelativeResize="0">
            <a:picLocks/>
          </p:cNvPicPr>
          <p:nvPr/>
        </p:nvPicPr>
        <p:blipFill>
          <a:blip r:embed="rId4">
            <a:grayscl/>
          </a:blip>
          <a:stretch>
            <a:fillRect/>
          </a:stretch>
        </p:blipFill>
        <p:spPr>
          <a:xfrm>
            <a:off x="5071968" y="723899"/>
            <a:ext cx="1664208" cy="1792224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72CBC1E6-8E38-4091-89B8-C86C959E2BA3}"/>
              </a:ext>
            </a:extLst>
          </p:cNvPr>
          <p:cNvSpPr txBox="1"/>
          <p:nvPr/>
        </p:nvSpPr>
        <p:spPr>
          <a:xfrm>
            <a:off x="2763646" y="442875"/>
            <a:ext cx="196902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NFKB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variant3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BAF7C947-05B3-465B-AD16-27BB3A763509}"/>
              </a:ext>
            </a:extLst>
          </p:cNvPr>
          <p:cNvPicPr preferRelativeResize="0">
            <a:picLocks/>
          </p:cNvPicPr>
          <p:nvPr/>
        </p:nvPicPr>
        <p:blipFill>
          <a:blip r:embed="rId5">
            <a:grayscl/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9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298831" y="673378"/>
            <a:ext cx="1664208" cy="1792224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24F1AADF-92F7-4BBA-9578-3305E35F9EA2}"/>
              </a:ext>
            </a:extLst>
          </p:cNvPr>
          <p:cNvSpPr txBox="1"/>
          <p:nvPr/>
        </p:nvSpPr>
        <p:spPr>
          <a:xfrm>
            <a:off x="6849213" y="673378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.2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B9472A6-F6A7-4AB5-B5BB-5945B239D2F5}"/>
              </a:ext>
            </a:extLst>
          </p:cNvPr>
          <p:cNvSpPr txBox="1"/>
          <p:nvPr/>
        </p:nvSpPr>
        <p:spPr>
          <a:xfrm>
            <a:off x="6849213" y="1453010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7.0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1B4FDAD-166D-400B-B8EA-C53DE593CC8D}"/>
              </a:ext>
            </a:extLst>
          </p:cNvPr>
          <p:cNvSpPr txBox="1"/>
          <p:nvPr/>
        </p:nvSpPr>
        <p:spPr>
          <a:xfrm>
            <a:off x="4629657" y="1044132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6.7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0A1F59C-654D-4BB8-80F2-A52A8C58DE53}"/>
              </a:ext>
            </a:extLst>
          </p:cNvPr>
          <p:cNvSpPr txBox="1"/>
          <p:nvPr/>
        </p:nvSpPr>
        <p:spPr>
          <a:xfrm>
            <a:off x="4629657" y="1823764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6.5</a:t>
            </a:r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94E28E3C-C7A0-4A51-ADA2-587C7D39E507}"/>
              </a:ext>
            </a:extLst>
          </p:cNvPr>
          <p:cNvPicPr preferRelativeResize="0">
            <a:picLocks/>
          </p:cNvPicPr>
          <p:nvPr/>
        </p:nvPicPr>
        <p:blipFill>
          <a:blip r:embed="rId7">
            <a:grayscl/>
          </a:blip>
          <a:stretch>
            <a:fillRect/>
          </a:stretch>
        </p:blipFill>
        <p:spPr>
          <a:xfrm>
            <a:off x="578690" y="3647242"/>
            <a:ext cx="1664208" cy="1792225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13F4C26F-6B07-42F2-9A16-2AA89A912030}"/>
              </a:ext>
            </a:extLst>
          </p:cNvPr>
          <p:cNvPicPr preferRelativeResize="0">
            <a:picLocks/>
          </p:cNvPicPr>
          <p:nvPr/>
        </p:nvPicPr>
        <p:blipFill>
          <a:blip r:embed="rId8">
            <a:grayscl/>
          </a:blip>
          <a:stretch>
            <a:fillRect/>
          </a:stretch>
        </p:blipFill>
        <p:spPr>
          <a:xfrm>
            <a:off x="2853933" y="3655402"/>
            <a:ext cx="1664208" cy="1792224"/>
          </a:xfrm>
          <a:prstGeom prst="rect">
            <a:avLst/>
          </a:prstGeom>
        </p:spPr>
      </p:pic>
      <p:sp>
        <p:nvSpPr>
          <p:cNvPr id="62" name="TextBox 61">
            <a:extLst>
              <a:ext uri="{FF2B5EF4-FFF2-40B4-BE49-F238E27FC236}">
                <a16:creationId xmlns:a16="http://schemas.microsoft.com/office/drawing/2014/main" id="{222F6B75-5B63-4DBC-B2EF-8F8A4BB13A05}"/>
              </a:ext>
            </a:extLst>
          </p:cNvPr>
          <p:cNvSpPr txBox="1"/>
          <p:nvPr/>
        </p:nvSpPr>
        <p:spPr>
          <a:xfrm>
            <a:off x="2747722" y="3451590"/>
            <a:ext cx="2220820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NFKB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variant1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6E2E4D1D-448A-4E86-81CE-1DFED3191321}"/>
              </a:ext>
            </a:extLst>
          </p:cNvPr>
          <p:cNvSpPr txBox="1"/>
          <p:nvPr/>
        </p:nvSpPr>
        <p:spPr>
          <a:xfrm>
            <a:off x="7250663" y="442875"/>
            <a:ext cx="192596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NFKB1 variant 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D25363B-4031-441A-8197-C3ADBAF65C87}"/>
              </a:ext>
            </a:extLst>
          </p:cNvPr>
          <p:cNvSpPr txBox="1"/>
          <p:nvPr/>
        </p:nvSpPr>
        <p:spPr>
          <a:xfrm>
            <a:off x="540667" y="3440508"/>
            <a:ext cx="222082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Rel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5" name="Picture 64">
            <a:extLst>
              <a:ext uri="{FF2B5EF4-FFF2-40B4-BE49-F238E27FC236}">
                <a16:creationId xmlns:a16="http://schemas.microsoft.com/office/drawing/2014/main" id="{E1292DD2-32F1-480F-97F7-B41D82473370}"/>
              </a:ext>
            </a:extLst>
          </p:cNvPr>
          <p:cNvPicPr preferRelativeResize="0">
            <a:picLocks/>
          </p:cNvPicPr>
          <p:nvPr/>
        </p:nvPicPr>
        <p:blipFill>
          <a:blip r:embed="rId9">
            <a:grayscl/>
          </a:blip>
          <a:stretch>
            <a:fillRect/>
          </a:stretch>
        </p:blipFill>
        <p:spPr>
          <a:xfrm>
            <a:off x="5502629" y="3624702"/>
            <a:ext cx="1664208" cy="1792224"/>
          </a:xfrm>
          <a:prstGeom prst="rect">
            <a:avLst/>
          </a:prstGeom>
        </p:spPr>
      </p:pic>
      <p:sp>
        <p:nvSpPr>
          <p:cNvPr id="73" name="TextBox 72">
            <a:extLst>
              <a:ext uri="{FF2B5EF4-FFF2-40B4-BE49-F238E27FC236}">
                <a16:creationId xmlns:a16="http://schemas.microsoft.com/office/drawing/2014/main" id="{6E949FE7-CDF8-4D97-BA97-AD3463B087D2}"/>
              </a:ext>
            </a:extLst>
          </p:cNvPr>
          <p:cNvSpPr txBox="1"/>
          <p:nvPr/>
        </p:nvSpPr>
        <p:spPr>
          <a:xfrm>
            <a:off x="5382514" y="3440411"/>
            <a:ext cx="2220820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IKBKG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variant2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1BFE37E3-1F87-46D2-A0A0-CA6668965E0A}"/>
              </a:ext>
            </a:extLst>
          </p:cNvPr>
          <p:cNvSpPr txBox="1"/>
          <p:nvPr/>
        </p:nvSpPr>
        <p:spPr>
          <a:xfrm>
            <a:off x="5075394" y="4529432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6.4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8278504D-3DA9-484B-BF13-63406B2356B1}"/>
              </a:ext>
            </a:extLst>
          </p:cNvPr>
          <p:cNvSpPr txBox="1"/>
          <p:nvPr/>
        </p:nvSpPr>
        <p:spPr>
          <a:xfrm>
            <a:off x="5075394" y="3983974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6.5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9E1A48F7-333D-464C-99EE-7E358F0A6A51}"/>
              </a:ext>
            </a:extLst>
          </p:cNvPr>
          <p:cNvSpPr txBox="1"/>
          <p:nvPr/>
        </p:nvSpPr>
        <p:spPr>
          <a:xfrm>
            <a:off x="5075394" y="5086040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6.3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5BB75370-FF64-4EE2-B8DB-F48B17DC80ED}"/>
              </a:ext>
            </a:extLst>
          </p:cNvPr>
          <p:cNvSpPr txBox="1"/>
          <p:nvPr/>
        </p:nvSpPr>
        <p:spPr>
          <a:xfrm>
            <a:off x="2406108" y="4272835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6.9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7F313CCC-30F5-438B-B8D1-E1FE12AA1BF3}"/>
              </a:ext>
            </a:extLst>
          </p:cNvPr>
          <p:cNvSpPr txBox="1"/>
          <p:nvPr/>
        </p:nvSpPr>
        <p:spPr>
          <a:xfrm>
            <a:off x="2406108" y="3727377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7.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54203C9B-6C3A-4E16-A403-4E746586E515}"/>
              </a:ext>
            </a:extLst>
          </p:cNvPr>
          <p:cNvSpPr txBox="1"/>
          <p:nvPr/>
        </p:nvSpPr>
        <p:spPr>
          <a:xfrm>
            <a:off x="2406108" y="4829443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6.8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3A8D1344-F4B2-4AE6-B105-5E748B9E35F9}"/>
              </a:ext>
            </a:extLst>
          </p:cNvPr>
          <p:cNvSpPr txBox="1"/>
          <p:nvPr/>
        </p:nvSpPr>
        <p:spPr>
          <a:xfrm>
            <a:off x="156408" y="3776200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8.2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D2FCE230-207D-47A5-8D20-9BAB5B8BA52A}"/>
              </a:ext>
            </a:extLst>
          </p:cNvPr>
          <p:cNvSpPr txBox="1"/>
          <p:nvPr/>
        </p:nvSpPr>
        <p:spPr>
          <a:xfrm>
            <a:off x="146163" y="4520814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8.0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8F171F3A-B62C-4F26-811C-F63A022FE11C}"/>
              </a:ext>
            </a:extLst>
          </p:cNvPr>
          <p:cNvSpPr txBox="1"/>
          <p:nvPr/>
        </p:nvSpPr>
        <p:spPr>
          <a:xfrm>
            <a:off x="7250663" y="4301531"/>
            <a:ext cx="189333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* Significantly associated with </a:t>
            </a:r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mtOx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cluster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B989046F-6EA8-42CF-99EF-BE8C2A1C95F7}"/>
              </a:ext>
            </a:extLst>
          </p:cNvPr>
          <p:cNvSpPr txBox="1"/>
          <p:nvPr/>
        </p:nvSpPr>
        <p:spPr>
          <a:xfrm>
            <a:off x="5567643" y="543361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2D5FC035-C93A-4EF1-94E2-D082F92E4CC6}"/>
              </a:ext>
            </a:extLst>
          </p:cNvPr>
          <p:cNvSpPr txBox="1"/>
          <p:nvPr/>
        </p:nvSpPr>
        <p:spPr>
          <a:xfrm>
            <a:off x="5775684" y="543361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79051D03-1824-49DF-A90F-A89C64B49CD2}"/>
              </a:ext>
            </a:extLst>
          </p:cNvPr>
          <p:cNvSpPr txBox="1"/>
          <p:nvPr/>
        </p:nvSpPr>
        <p:spPr>
          <a:xfrm>
            <a:off x="5983725" y="543361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EF4A21CF-E77A-4850-B44D-90A77873FE55}"/>
              </a:ext>
            </a:extLst>
          </p:cNvPr>
          <p:cNvSpPr txBox="1"/>
          <p:nvPr/>
        </p:nvSpPr>
        <p:spPr>
          <a:xfrm>
            <a:off x="6191766" y="543361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A05FAD3D-0CD1-432E-AD78-0FCC99D07C6C}"/>
              </a:ext>
            </a:extLst>
          </p:cNvPr>
          <p:cNvSpPr txBox="1"/>
          <p:nvPr/>
        </p:nvSpPr>
        <p:spPr>
          <a:xfrm>
            <a:off x="6499193" y="543361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A5BAF5B6-63A0-4C73-A037-E68A38FDB0B2}"/>
              </a:ext>
            </a:extLst>
          </p:cNvPr>
          <p:cNvSpPr txBox="1"/>
          <p:nvPr/>
        </p:nvSpPr>
        <p:spPr>
          <a:xfrm>
            <a:off x="6806620" y="5444252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B1FA055B-6936-473A-A9E8-C7E5598F487E}"/>
              </a:ext>
            </a:extLst>
          </p:cNvPr>
          <p:cNvSpPr txBox="1"/>
          <p:nvPr/>
        </p:nvSpPr>
        <p:spPr>
          <a:xfrm>
            <a:off x="6143885" y="5662258"/>
            <a:ext cx="5036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n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F10FDE30-090A-4DC7-9D2A-558E1B72EFE4}"/>
              </a:ext>
            </a:extLst>
          </p:cNvPr>
          <p:cNvSpPr txBox="1"/>
          <p:nvPr/>
        </p:nvSpPr>
        <p:spPr>
          <a:xfrm>
            <a:off x="2894751" y="544351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B0A277F4-A3C2-4D3A-B8CB-8CE719498727}"/>
              </a:ext>
            </a:extLst>
          </p:cNvPr>
          <p:cNvSpPr txBox="1"/>
          <p:nvPr/>
        </p:nvSpPr>
        <p:spPr>
          <a:xfrm>
            <a:off x="3102792" y="544351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FF87F68C-3683-4B12-8796-AB5AC6B23C17}"/>
              </a:ext>
            </a:extLst>
          </p:cNvPr>
          <p:cNvSpPr txBox="1"/>
          <p:nvPr/>
        </p:nvSpPr>
        <p:spPr>
          <a:xfrm>
            <a:off x="3310833" y="544351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F5AA6EDA-7405-45B2-B740-BD8E1F20EE89}"/>
              </a:ext>
            </a:extLst>
          </p:cNvPr>
          <p:cNvSpPr txBox="1"/>
          <p:nvPr/>
        </p:nvSpPr>
        <p:spPr>
          <a:xfrm>
            <a:off x="3518874" y="544351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260745EB-A695-413A-B2D4-0554B930054C}"/>
              </a:ext>
            </a:extLst>
          </p:cNvPr>
          <p:cNvSpPr txBox="1"/>
          <p:nvPr/>
        </p:nvSpPr>
        <p:spPr>
          <a:xfrm>
            <a:off x="3826301" y="544351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01B72453-B525-4563-AAE5-7C6CAEA712EB}"/>
              </a:ext>
            </a:extLst>
          </p:cNvPr>
          <p:cNvSpPr txBox="1"/>
          <p:nvPr/>
        </p:nvSpPr>
        <p:spPr>
          <a:xfrm>
            <a:off x="4133728" y="5454151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B486D056-AFF8-4B8D-A859-F9130EEE86CA}"/>
              </a:ext>
            </a:extLst>
          </p:cNvPr>
          <p:cNvSpPr txBox="1"/>
          <p:nvPr/>
        </p:nvSpPr>
        <p:spPr>
          <a:xfrm>
            <a:off x="3470993" y="5672157"/>
            <a:ext cx="5036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n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ADAD0F6E-FED2-4E21-BDE1-32B6F440CC10}"/>
              </a:ext>
            </a:extLst>
          </p:cNvPr>
          <p:cNvSpPr txBox="1"/>
          <p:nvPr/>
        </p:nvSpPr>
        <p:spPr>
          <a:xfrm>
            <a:off x="590060" y="542367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675459A9-A164-4550-989D-06A5EABFC790}"/>
              </a:ext>
            </a:extLst>
          </p:cNvPr>
          <p:cNvSpPr txBox="1"/>
          <p:nvPr/>
        </p:nvSpPr>
        <p:spPr>
          <a:xfrm>
            <a:off x="798101" y="542367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CBB482D0-E9E6-455E-9D4D-49AD87C30E7C}"/>
              </a:ext>
            </a:extLst>
          </p:cNvPr>
          <p:cNvSpPr txBox="1"/>
          <p:nvPr/>
        </p:nvSpPr>
        <p:spPr>
          <a:xfrm>
            <a:off x="1006142" y="542367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807A2DB1-DDEE-4141-9155-F9A8977F2F5D}"/>
              </a:ext>
            </a:extLst>
          </p:cNvPr>
          <p:cNvSpPr txBox="1"/>
          <p:nvPr/>
        </p:nvSpPr>
        <p:spPr>
          <a:xfrm>
            <a:off x="1214183" y="542367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25E52278-2248-4269-86B5-7B84DC5F10E0}"/>
              </a:ext>
            </a:extLst>
          </p:cNvPr>
          <p:cNvSpPr txBox="1"/>
          <p:nvPr/>
        </p:nvSpPr>
        <p:spPr>
          <a:xfrm>
            <a:off x="1521610" y="542367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7B83D658-FBD2-4EF1-830B-FA5C21E94FF6}"/>
              </a:ext>
            </a:extLst>
          </p:cNvPr>
          <p:cNvSpPr txBox="1"/>
          <p:nvPr/>
        </p:nvSpPr>
        <p:spPr>
          <a:xfrm>
            <a:off x="1829037" y="5434305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08429AB1-6AB3-4A8A-AFF4-D70313284035}"/>
              </a:ext>
            </a:extLst>
          </p:cNvPr>
          <p:cNvSpPr txBox="1"/>
          <p:nvPr/>
        </p:nvSpPr>
        <p:spPr>
          <a:xfrm>
            <a:off x="1166302" y="5652311"/>
            <a:ext cx="5036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n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79F6F5CE-363F-4B34-BCEA-72EF0B3728AA}"/>
              </a:ext>
            </a:extLst>
          </p:cNvPr>
          <p:cNvSpPr txBox="1"/>
          <p:nvPr/>
        </p:nvSpPr>
        <p:spPr>
          <a:xfrm>
            <a:off x="7381930" y="2438705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3D0D53DC-A8FB-4212-8AAD-4CD1C380C95A}"/>
              </a:ext>
            </a:extLst>
          </p:cNvPr>
          <p:cNvSpPr txBox="1"/>
          <p:nvPr/>
        </p:nvSpPr>
        <p:spPr>
          <a:xfrm>
            <a:off x="7589971" y="2438705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CCD601A1-D6A9-457A-9931-F9698B86BC31}"/>
              </a:ext>
            </a:extLst>
          </p:cNvPr>
          <p:cNvSpPr txBox="1"/>
          <p:nvPr/>
        </p:nvSpPr>
        <p:spPr>
          <a:xfrm>
            <a:off x="7798012" y="2438705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C7C9D958-0044-430B-A3C9-634D77F85B8F}"/>
              </a:ext>
            </a:extLst>
          </p:cNvPr>
          <p:cNvSpPr txBox="1"/>
          <p:nvPr/>
        </p:nvSpPr>
        <p:spPr>
          <a:xfrm>
            <a:off x="8006053" y="243870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035663E1-6E86-489E-9C48-7BA310A3D4DB}"/>
              </a:ext>
            </a:extLst>
          </p:cNvPr>
          <p:cNvSpPr txBox="1"/>
          <p:nvPr/>
        </p:nvSpPr>
        <p:spPr>
          <a:xfrm>
            <a:off x="8313480" y="243870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8B6FA4BD-0467-4A69-89CA-D448BFBA82BE}"/>
              </a:ext>
            </a:extLst>
          </p:cNvPr>
          <p:cNvSpPr txBox="1"/>
          <p:nvPr/>
        </p:nvSpPr>
        <p:spPr>
          <a:xfrm>
            <a:off x="8620907" y="2449338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E9170C6C-3113-4A10-AF57-2F21A51DB2C6}"/>
              </a:ext>
            </a:extLst>
          </p:cNvPr>
          <p:cNvSpPr txBox="1"/>
          <p:nvPr/>
        </p:nvSpPr>
        <p:spPr>
          <a:xfrm>
            <a:off x="7958172" y="2667344"/>
            <a:ext cx="5036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n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2F1E9521-36FD-4A16-A8EE-7155460C24AD}"/>
              </a:ext>
            </a:extLst>
          </p:cNvPr>
          <p:cNvSpPr txBox="1"/>
          <p:nvPr/>
        </p:nvSpPr>
        <p:spPr>
          <a:xfrm>
            <a:off x="5127412" y="251292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5B2DD17F-5B91-4F4B-9D8E-7A0346D2665E}"/>
              </a:ext>
            </a:extLst>
          </p:cNvPr>
          <p:cNvSpPr txBox="1"/>
          <p:nvPr/>
        </p:nvSpPr>
        <p:spPr>
          <a:xfrm>
            <a:off x="5335453" y="251292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17618650-8499-4428-AC6B-9B4DE7522BF8}"/>
              </a:ext>
            </a:extLst>
          </p:cNvPr>
          <p:cNvSpPr txBox="1"/>
          <p:nvPr/>
        </p:nvSpPr>
        <p:spPr>
          <a:xfrm>
            <a:off x="5543494" y="251292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396163A3-AE5D-49AF-8029-838F3D9CBC03}"/>
              </a:ext>
            </a:extLst>
          </p:cNvPr>
          <p:cNvSpPr txBox="1"/>
          <p:nvPr/>
        </p:nvSpPr>
        <p:spPr>
          <a:xfrm>
            <a:off x="5751535" y="251292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9AAB27E7-C65D-417F-A3B3-22F413E4C815}"/>
              </a:ext>
            </a:extLst>
          </p:cNvPr>
          <p:cNvSpPr txBox="1"/>
          <p:nvPr/>
        </p:nvSpPr>
        <p:spPr>
          <a:xfrm>
            <a:off x="6058962" y="251292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A1BE7B8C-AF6E-44F6-A353-F8B82888EFFA}"/>
              </a:ext>
            </a:extLst>
          </p:cNvPr>
          <p:cNvSpPr txBox="1"/>
          <p:nvPr/>
        </p:nvSpPr>
        <p:spPr>
          <a:xfrm>
            <a:off x="6366389" y="2523554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EE1719B1-C43F-4A0C-BC87-FF2D134B4D0F}"/>
              </a:ext>
            </a:extLst>
          </p:cNvPr>
          <p:cNvSpPr txBox="1"/>
          <p:nvPr/>
        </p:nvSpPr>
        <p:spPr>
          <a:xfrm>
            <a:off x="5703654" y="2741560"/>
            <a:ext cx="5036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n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15E2F698-7AED-4C5F-AC0D-7227632FA8EA}"/>
              </a:ext>
            </a:extLst>
          </p:cNvPr>
          <p:cNvSpPr txBox="1"/>
          <p:nvPr/>
        </p:nvSpPr>
        <p:spPr>
          <a:xfrm>
            <a:off x="2807885" y="247230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092EA888-8B3B-4F09-B634-D25A092E7011}"/>
              </a:ext>
            </a:extLst>
          </p:cNvPr>
          <p:cNvSpPr txBox="1"/>
          <p:nvPr/>
        </p:nvSpPr>
        <p:spPr>
          <a:xfrm>
            <a:off x="3015926" y="247230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44B7478B-AD77-42F9-8E6C-2FE61EDA5358}"/>
              </a:ext>
            </a:extLst>
          </p:cNvPr>
          <p:cNvSpPr txBox="1"/>
          <p:nvPr/>
        </p:nvSpPr>
        <p:spPr>
          <a:xfrm>
            <a:off x="3223967" y="247230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2CEC22DE-0320-46EB-9538-CA9C8DEC6F67}"/>
              </a:ext>
            </a:extLst>
          </p:cNvPr>
          <p:cNvSpPr txBox="1"/>
          <p:nvPr/>
        </p:nvSpPr>
        <p:spPr>
          <a:xfrm>
            <a:off x="3432008" y="247230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87608B6C-8671-46B0-B0A5-3B968F73E0B4}"/>
              </a:ext>
            </a:extLst>
          </p:cNvPr>
          <p:cNvSpPr txBox="1"/>
          <p:nvPr/>
        </p:nvSpPr>
        <p:spPr>
          <a:xfrm>
            <a:off x="3739435" y="247230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1834B588-74DB-4C2F-9048-26B2D7EE5FE8}"/>
              </a:ext>
            </a:extLst>
          </p:cNvPr>
          <p:cNvSpPr txBox="1"/>
          <p:nvPr/>
        </p:nvSpPr>
        <p:spPr>
          <a:xfrm>
            <a:off x="4046862" y="2482941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4B68D337-91DB-4B74-AACD-2D6DF4D73436}"/>
              </a:ext>
            </a:extLst>
          </p:cNvPr>
          <p:cNvSpPr txBox="1"/>
          <p:nvPr/>
        </p:nvSpPr>
        <p:spPr>
          <a:xfrm>
            <a:off x="3384127" y="2700947"/>
            <a:ext cx="5036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n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E382B0AA-0F3F-48CF-8A34-C6A27DAF9C7D}"/>
              </a:ext>
            </a:extLst>
          </p:cNvPr>
          <p:cNvSpPr txBox="1"/>
          <p:nvPr/>
        </p:nvSpPr>
        <p:spPr>
          <a:xfrm>
            <a:off x="552906" y="250282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88331060-783C-41DD-8CA5-290E0101EC26}"/>
              </a:ext>
            </a:extLst>
          </p:cNvPr>
          <p:cNvSpPr txBox="1"/>
          <p:nvPr/>
        </p:nvSpPr>
        <p:spPr>
          <a:xfrm>
            <a:off x="760947" y="250282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B46822C7-5223-4335-8B89-CB7C0BFD11A8}"/>
              </a:ext>
            </a:extLst>
          </p:cNvPr>
          <p:cNvSpPr txBox="1"/>
          <p:nvPr/>
        </p:nvSpPr>
        <p:spPr>
          <a:xfrm>
            <a:off x="968988" y="250282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D2ADDF8F-3360-4341-A62F-ABB04EC4F165}"/>
              </a:ext>
            </a:extLst>
          </p:cNvPr>
          <p:cNvSpPr txBox="1"/>
          <p:nvPr/>
        </p:nvSpPr>
        <p:spPr>
          <a:xfrm>
            <a:off x="1177029" y="250282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85AE608B-BB4F-4121-AE08-5962078D8049}"/>
              </a:ext>
            </a:extLst>
          </p:cNvPr>
          <p:cNvSpPr txBox="1"/>
          <p:nvPr/>
        </p:nvSpPr>
        <p:spPr>
          <a:xfrm>
            <a:off x="1484456" y="250282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66532CE1-3412-4CBE-AAAC-ED728B8D7A7D}"/>
              </a:ext>
            </a:extLst>
          </p:cNvPr>
          <p:cNvSpPr txBox="1"/>
          <p:nvPr/>
        </p:nvSpPr>
        <p:spPr>
          <a:xfrm>
            <a:off x="1791883" y="2513455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4F23D5C7-570B-4AED-9BF2-D4D436742193}"/>
              </a:ext>
            </a:extLst>
          </p:cNvPr>
          <p:cNvSpPr txBox="1"/>
          <p:nvPr/>
        </p:nvSpPr>
        <p:spPr>
          <a:xfrm>
            <a:off x="1129148" y="2731461"/>
            <a:ext cx="5036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n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3AF11246-FA91-4C1D-BCDC-441A7240AEF3}"/>
              </a:ext>
            </a:extLst>
          </p:cNvPr>
          <p:cNvSpPr txBox="1"/>
          <p:nvPr/>
        </p:nvSpPr>
        <p:spPr>
          <a:xfrm>
            <a:off x="156407" y="6131479"/>
            <a:ext cx="620998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0" u="none" strike="noStrike" baseline="0" dirty="0">
                <a:latin typeface="URWPalladioL-Roma"/>
              </a:rPr>
              <a:t>Figure S3: </a:t>
            </a:r>
            <a:r>
              <a:rPr lang="en-US" sz="1800" b="0" i="0" u="none" strike="noStrike" baseline="0" dirty="0">
                <a:latin typeface="URWPalladioL-Roma"/>
              </a:rPr>
              <a:t>Transcript data for other NF-kB component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173167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4</TotalTime>
  <Words>96</Words>
  <Application>Microsoft Office PowerPoint</Application>
  <PresentationFormat>On-screen Show (4:3)</PresentationFormat>
  <Paragraphs>7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URWPalladioL-Roma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ernandes, Jolyn   (HSC)</dc:creator>
  <cp:lastModifiedBy>MDPI</cp:lastModifiedBy>
  <cp:revision>29</cp:revision>
  <dcterms:created xsi:type="dcterms:W3CDTF">2021-03-17T04:15:48Z</dcterms:created>
  <dcterms:modified xsi:type="dcterms:W3CDTF">2023-03-25T10:22:27Z</dcterms:modified>
</cp:coreProperties>
</file>